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950075" cy="923607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59" d="100"/>
          <a:sy n="59" d="100"/>
        </p:scale>
        <p:origin x="-2316" y="-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kahleova\Desktop\fMRI%20vysledky%20Hill\gl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kahleova\Desktop\fMRI%20vysledky%20Hill\IRI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kahleova\Desktop\fMRI%20vysledky%20Hill\Cpepti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kahleova\Desktop\fMRI%20vysledky%20Hill\Amylintot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kahleova\Desktop\fMRI%20vysledky%20Hill\GLP1act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kahleova\Desktop\fMRI%20vysledky%20Hill\GIP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4:$Q$78</c:f>
                <c:numCache>
                  <c:formatCode>General</c:formatCode>
                  <c:ptCount val="5"/>
                  <c:pt idx="0">
                    <c:v>0.20697739968838391</c:v>
                  </c:pt>
                  <c:pt idx="1">
                    <c:v>0.49732514701788055</c:v>
                  </c:pt>
                  <c:pt idx="2">
                    <c:v>0.56409752832517945</c:v>
                  </c:pt>
                  <c:pt idx="3">
                    <c:v>0.29702501380703339</c:v>
                  </c:pt>
                  <c:pt idx="4">
                    <c:v>0.19264593570809829</c:v>
                  </c:pt>
                </c:numCache>
              </c:numRef>
            </c:plus>
            <c:minus>
              <c:numRef>
                <c:f>dia!$P$74:$P$78</c:f>
                <c:numCache>
                  <c:formatCode>General</c:formatCode>
                  <c:ptCount val="5"/>
                  <c:pt idx="0">
                    <c:v>0.19363323784266306</c:v>
                  </c:pt>
                  <c:pt idx="1">
                    <c:v>0.44070224587980533</c:v>
                  </c:pt>
                  <c:pt idx="2">
                    <c:v>0.49456691712704171</c:v>
                  </c:pt>
                  <c:pt idx="3">
                    <c:v>0.27274455511465945</c:v>
                  </c:pt>
                  <c:pt idx="4">
                    <c:v>0.180605603004034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4:$M$78</c:f>
              <c:numCache>
                <c:formatCode>General</c:formatCode>
                <c:ptCount val="5"/>
                <c:pt idx="0">
                  <c:v>6.8173570260873806</c:v>
                </c:pt>
                <c:pt idx="1">
                  <c:v>9.7168043594331301</c:v>
                </c:pt>
                <c:pt idx="2">
                  <c:v>10.190793475633232</c:v>
                </c:pt>
                <c:pt idx="3">
                  <c:v>7.9304975198890322</c:v>
                </c:pt>
                <c:pt idx="4">
                  <c:v>6.4376449662318649</c:v>
                </c:pt>
              </c:numCache>
            </c:numRef>
          </c:val>
          <c:smooth val="0"/>
        </c:ser>
        <c:ser>
          <c:idx val="1"/>
          <c:order val="1"/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9:$Q$83</c:f>
                <c:numCache>
                  <c:formatCode>General</c:formatCode>
                  <c:ptCount val="5"/>
                  <c:pt idx="0">
                    <c:v>0.21379093486829071</c:v>
                  </c:pt>
                  <c:pt idx="1">
                    <c:v>0.48494359101753304</c:v>
                  </c:pt>
                  <c:pt idx="2">
                    <c:v>0.62577728453928927</c:v>
                  </c:pt>
                  <c:pt idx="3">
                    <c:v>0.33170601239573827</c:v>
                  </c:pt>
                  <c:pt idx="4">
                    <c:v>0.19431198175379727</c:v>
                  </c:pt>
                </c:numCache>
              </c:numRef>
            </c:plus>
            <c:minus>
              <c:numRef>
                <c:f>dia!$P$79:$P$83</c:f>
                <c:numCache>
                  <c:formatCode>General</c:formatCode>
                  <c:ptCount val="5"/>
                  <c:pt idx="0">
                    <c:v>0.1997088888007017</c:v>
                  </c:pt>
                  <c:pt idx="1">
                    <c:v>0.4306049613858125</c:v>
                  </c:pt>
                  <c:pt idx="2">
                    <c:v>0.5434779705734023</c:v>
                  </c:pt>
                  <c:pt idx="3">
                    <c:v>0.30257234066396421</c:v>
                  </c:pt>
                  <c:pt idx="4">
                    <c:v>0.18209793250714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9:$M$83</c:f>
              <c:numCache>
                <c:formatCode>General</c:formatCode>
                <c:ptCount val="5"/>
                <c:pt idx="0">
                  <c:v>6.9127550503332511</c:v>
                </c:pt>
                <c:pt idx="1">
                  <c:v>9.6237551798285317</c:v>
                </c:pt>
                <c:pt idx="2">
                  <c:v>10.592598486605548</c:v>
                </c:pt>
                <c:pt idx="3">
                  <c:v>8.2930796026625604</c:v>
                </c:pt>
                <c:pt idx="4">
                  <c:v>6.461957697384093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9795328"/>
        <c:axId val="79797248"/>
      </c:lineChart>
      <c:catAx>
        <c:axId val="797953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Time (min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797248"/>
        <c:crosses val="autoZero"/>
        <c:auto val="1"/>
        <c:lblAlgn val="ctr"/>
        <c:lblOffset val="100"/>
        <c:noMultiLvlLbl val="0"/>
      </c:catAx>
      <c:valAx>
        <c:axId val="79797248"/>
        <c:scaling>
          <c:orientation val="minMax"/>
          <c:min val="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Glucose (mmol/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97953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4:$Q$78</c:f>
                <c:numCache>
                  <c:formatCode>General</c:formatCode>
                  <c:ptCount val="5"/>
                  <c:pt idx="0">
                    <c:v>1.3240832435578938</c:v>
                  </c:pt>
                  <c:pt idx="1">
                    <c:v>4.3328100433893226</c:v>
                  </c:pt>
                  <c:pt idx="2">
                    <c:v>6.7839573986062049</c:v>
                  </c:pt>
                  <c:pt idx="3">
                    <c:v>4.6605589029293597</c:v>
                  </c:pt>
                  <c:pt idx="4">
                    <c:v>2.1467746667841077</c:v>
                  </c:pt>
                </c:numCache>
              </c:numRef>
            </c:plus>
            <c:minus>
              <c:numRef>
                <c:f>dia!$P$74:$P$78</c:f>
                <c:numCache>
                  <c:formatCode>General</c:formatCode>
                  <c:ptCount val="5"/>
                  <c:pt idx="0">
                    <c:v>1.2154874256010437</c:v>
                  </c:pt>
                  <c:pt idx="1">
                    <c:v>3.9311367852545445</c:v>
                  </c:pt>
                  <c:pt idx="2">
                    <c:v>6.1253691783785911</c:v>
                  </c:pt>
                  <c:pt idx="3">
                    <c:v>4.225245290227754</c:v>
                  </c:pt>
                  <c:pt idx="4">
                    <c:v>1.96166559864094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4:$M$78</c:f>
              <c:numCache>
                <c:formatCode>General</c:formatCode>
                <c:ptCount val="5"/>
                <c:pt idx="0">
                  <c:v>13.423597513002878</c:v>
                </c:pt>
                <c:pt idx="1">
                  <c:v>44.371229606146883</c:v>
                </c:pt>
                <c:pt idx="2">
                  <c:v>67.584664000687923</c:v>
                </c:pt>
                <c:pt idx="3">
                  <c:v>47.547990572928668</c:v>
                </c:pt>
                <c:pt idx="4">
                  <c:v>22.320416655999335</c:v>
                </c:pt>
              </c:numCache>
            </c:numRef>
          </c:val>
          <c:smooth val="0"/>
        </c:ser>
        <c:ser>
          <c:idx val="1"/>
          <c:order val="1"/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9:$Q$83</c:f>
                <c:numCache>
                  <c:formatCode>General</c:formatCode>
                  <c:ptCount val="5"/>
                  <c:pt idx="0">
                    <c:v>1.3226981893317493</c:v>
                  </c:pt>
                  <c:pt idx="1">
                    <c:v>4.3294152186453445</c:v>
                  </c:pt>
                  <c:pt idx="2">
                    <c:v>6.9972161581293193</c:v>
                  </c:pt>
                  <c:pt idx="3">
                    <c:v>5.5066284314699629</c:v>
                  </c:pt>
                  <c:pt idx="4">
                    <c:v>3.248859599985515</c:v>
                  </c:pt>
                </c:numCache>
              </c:numRef>
            </c:plus>
            <c:minus>
              <c:numRef>
                <c:f>dia!$P$79:$P$83</c:f>
                <c:numCache>
                  <c:formatCode>General</c:formatCode>
                  <c:ptCount val="5"/>
                  <c:pt idx="0">
                    <c:v>1.2142277378700399</c:v>
                  </c:pt>
                  <c:pt idx="1">
                    <c:v>3.92808907817912</c:v>
                  </c:pt>
                  <c:pt idx="2">
                    <c:v>6.3157618613524988</c:v>
                  </c:pt>
                  <c:pt idx="3">
                    <c:v>4.9833995579581014</c:v>
                  </c:pt>
                  <c:pt idx="4">
                    <c:v>2.95649023963931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9:$M$83</c:f>
              <c:numCache>
                <c:formatCode>General</c:formatCode>
                <c:ptCount val="5"/>
                <c:pt idx="0">
                  <c:v>13.4081680772025</c:v>
                </c:pt>
                <c:pt idx="1">
                  <c:v>44.338184419305193</c:v>
                </c:pt>
                <c:pt idx="2">
                  <c:v>69.553260604130642</c:v>
                </c:pt>
                <c:pt idx="3">
                  <c:v>55.637509104102492</c:v>
                </c:pt>
                <c:pt idx="4">
                  <c:v>33.6550354812118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424768"/>
        <c:axId val="81426688"/>
      </c:lineChart>
      <c:catAx>
        <c:axId val="8142476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Time</a:t>
                </a:r>
                <a:r>
                  <a:rPr lang="en-US" sz="1200"/>
                  <a:t> </a:t>
                </a:r>
                <a:r>
                  <a:rPr lang="en-US" sz="1200" b="1"/>
                  <a:t>(min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426688"/>
        <c:crosses val="autoZero"/>
        <c:auto val="1"/>
        <c:lblAlgn val="ctr"/>
        <c:lblOffset val="100"/>
        <c:noMultiLvlLbl val="0"/>
      </c:catAx>
      <c:valAx>
        <c:axId val="814266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dirty="0" smtClean="0"/>
                  <a:t>Insulin </a:t>
                </a:r>
                <a:r>
                  <a:rPr lang="en-US" sz="1000" b="1" i="0" u="none" strike="noStrike" baseline="0" dirty="0" smtClean="0">
                    <a:effectLst/>
                  </a:rPr>
                  <a:t>(</a:t>
                </a:r>
                <a:r>
                  <a:rPr lang="en-US" sz="1000" b="1" i="0" u="none" strike="noStrike" baseline="0" dirty="0" err="1" smtClean="0">
                    <a:effectLst/>
                  </a:rPr>
                  <a:t>mIUl</a:t>
                </a:r>
                <a:r>
                  <a:rPr lang="en-US" sz="1000" b="1" i="0" u="none" strike="noStrike" baseline="0" dirty="0" smtClean="0">
                    <a:effectLst/>
                  </a:rPr>
                  <a:t>/L</a:t>
                </a:r>
                <a:r>
                  <a:rPr lang="en-US" sz="1000" b="1" dirty="0" smtClean="0"/>
                  <a:t>)</a:t>
                </a:r>
                <a:endParaRPr lang="en-US" sz="1000" b="1" dirty="0"/>
              </a:p>
            </c:rich>
          </c:tx>
          <c:layout>
            <c:manualLayout>
              <c:xMode val="edge"/>
              <c:yMode val="edge"/>
              <c:x val="5.6467583605370734E-2"/>
              <c:y val="8.0727680410181399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424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4:$Q$78</c:f>
                <c:numCache>
                  <c:formatCode>General</c:formatCode>
                  <c:ptCount val="5"/>
                  <c:pt idx="0">
                    <c:v>6.5132753167291613E-2</c:v>
                  </c:pt>
                  <c:pt idx="1">
                    <c:v>9.5109969142620931E-2</c:v>
                  </c:pt>
                  <c:pt idx="2">
                    <c:v>0.12319050118939989</c:v>
                  </c:pt>
                  <c:pt idx="3">
                    <c:v>0.12567198353324693</c:v>
                  </c:pt>
                  <c:pt idx="4">
                    <c:v>9.9483598527747574E-2</c:v>
                  </c:pt>
                </c:numCache>
              </c:numRef>
            </c:plus>
            <c:minus>
              <c:numRef>
                <c:f>dia!$P$74:$P$78</c:f>
                <c:numCache>
                  <c:formatCode>General</c:formatCode>
                  <c:ptCount val="5"/>
                  <c:pt idx="0">
                    <c:v>6.2741909909844074E-2</c:v>
                  </c:pt>
                  <c:pt idx="1">
                    <c:v>9.1709855556912689E-2</c:v>
                  </c:pt>
                  <c:pt idx="2">
                    <c:v>0.11887233554975252</c:v>
                  </c:pt>
                  <c:pt idx="3">
                    <c:v>0.12126683601300625</c:v>
                  </c:pt>
                  <c:pt idx="4">
                    <c:v>9.593840244895868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4:$M$78</c:f>
              <c:numCache>
                <c:formatCode>General</c:formatCode>
                <c:ptCount val="5"/>
                <c:pt idx="0">
                  <c:v>1.1742722669209913</c:v>
                </c:pt>
                <c:pt idx="1">
                  <c:v>1.9730292726998775</c:v>
                </c:pt>
                <c:pt idx="2">
                  <c:v>2.7435809032141112</c:v>
                </c:pt>
                <c:pt idx="3">
                  <c:v>2.807316601656078</c:v>
                </c:pt>
                <c:pt idx="4">
                  <c:v>2.0913493448359173</c:v>
                </c:pt>
              </c:numCache>
            </c:numRef>
          </c:val>
          <c:smooth val="0"/>
        </c:ser>
        <c:ser>
          <c:idx val="1"/>
          <c:order val="1"/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9:$Q$83</c:f>
                <c:numCache>
                  <c:formatCode>General</c:formatCode>
                  <c:ptCount val="5"/>
                  <c:pt idx="0">
                    <c:v>6.5553000182710264E-2</c:v>
                  </c:pt>
                  <c:pt idx="1">
                    <c:v>9.8346083387540695E-2</c:v>
                  </c:pt>
                  <c:pt idx="2">
                    <c:v>0.13094030465269091</c:v>
                  </c:pt>
                  <c:pt idx="3">
                    <c:v>0.13371208327597506</c:v>
                  </c:pt>
                  <c:pt idx="4">
                    <c:v>0.12066647047503398</c:v>
                  </c:pt>
                </c:numCache>
              </c:numRef>
            </c:plus>
            <c:minus>
              <c:numRef>
                <c:f>dia!$P$79:$P$83</c:f>
                <c:numCache>
                  <c:formatCode>General</c:formatCode>
                  <c:ptCount val="5"/>
                  <c:pt idx="0">
                    <c:v>6.3147822717884772E-2</c:v>
                  </c:pt>
                  <c:pt idx="1">
                    <c:v>9.4838576881561609E-2</c:v>
                  </c:pt>
                  <c:pt idx="2">
                    <c:v>0.12622844583130544</c:v>
                  </c:pt>
                  <c:pt idx="3">
                    <c:v>0.12905216046205981</c:v>
                  </c:pt>
                  <c:pt idx="4">
                    <c:v>0.116299194645325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9:$M$83</c:f>
              <c:numCache>
                <c:formatCode>General</c:formatCode>
                <c:ptCount val="5"/>
                <c:pt idx="0">
                  <c:v>1.18531823692468</c:v>
                </c:pt>
                <c:pt idx="1">
                  <c:v>2.0605387753377267</c:v>
                </c:pt>
                <c:pt idx="2">
                  <c:v>2.8523587728793771</c:v>
                </c:pt>
                <c:pt idx="3">
                  <c:v>3.0344815895083666</c:v>
                </c:pt>
                <c:pt idx="4">
                  <c:v>2.57757158985348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460608"/>
        <c:axId val="81466880"/>
      </c:lineChart>
      <c:catAx>
        <c:axId val="8146060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/>
                  <a:t>Time </a:t>
                </a:r>
                <a:r>
                  <a:rPr lang="en-US" sz="1200" b="1" dirty="0" smtClean="0"/>
                  <a:t>(min</a:t>
                </a:r>
                <a:r>
                  <a:rPr lang="en-US" sz="1200" b="1" dirty="0"/>
                  <a:t>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466880"/>
        <c:crosses val="autoZero"/>
        <c:auto val="1"/>
        <c:lblAlgn val="ctr"/>
        <c:lblOffset val="100"/>
        <c:noMultiLvlLbl val="0"/>
      </c:catAx>
      <c:valAx>
        <c:axId val="814668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dirty="0" smtClean="0"/>
                  <a:t>C-peptide </a:t>
                </a:r>
                <a:r>
                  <a:rPr lang="en-US" sz="1200" b="1" i="0" u="none" strike="noStrike" baseline="0" dirty="0" smtClean="0">
                    <a:effectLst/>
                  </a:rPr>
                  <a:t>(</a:t>
                </a:r>
                <a:r>
                  <a:rPr lang="en-US" sz="1200" b="1" i="0" u="none" strike="noStrike" baseline="0" dirty="0" err="1" smtClean="0">
                    <a:effectLst/>
                  </a:rPr>
                  <a:t>nmol</a:t>
                </a:r>
                <a:r>
                  <a:rPr lang="en-US" sz="1200" b="1" i="0" u="none" strike="noStrike" baseline="0" dirty="0" smtClean="0">
                    <a:effectLst/>
                  </a:rPr>
                  <a:t>/L)</a:t>
                </a:r>
                <a:endParaRPr lang="en-US" sz="1000" b="1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460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4:$Q$78</c:f>
                <c:numCache>
                  <c:formatCode>General</c:formatCode>
                  <c:ptCount val="5"/>
                  <c:pt idx="0">
                    <c:v>1.9437819512837677</c:v>
                  </c:pt>
                  <c:pt idx="1">
                    <c:v>3.030744686799153</c:v>
                  </c:pt>
                  <c:pt idx="2">
                    <c:v>3.7866561859979555</c:v>
                  </c:pt>
                  <c:pt idx="3">
                    <c:v>3.7621387316411585</c:v>
                  </c:pt>
                  <c:pt idx="4">
                    <c:v>2.8859214867846106</c:v>
                  </c:pt>
                </c:numCache>
              </c:numRef>
            </c:plus>
            <c:minus>
              <c:numRef>
                <c:f>dia!$P$74:$P$78</c:f>
                <c:numCache>
                  <c:formatCode>General</c:formatCode>
                  <c:ptCount val="5"/>
                  <c:pt idx="0">
                    <c:v>1.8554548219912554</c:v>
                  </c:pt>
                  <c:pt idx="1">
                    <c:v>2.9050694227866813</c:v>
                  </c:pt>
                  <c:pt idx="2">
                    <c:v>3.6314974823825423</c:v>
                  </c:pt>
                  <c:pt idx="3">
                    <c:v>3.6128540779804155</c:v>
                  </c:pt>
                  <c:pt idx="4">
                    <c:v>2.76504031012821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4:$M$78</c:f>
              <c:numCache>
                <c:formatCode>General</c:formatCode>
                <c:ptCount val="5"/>
                <c:pt idx="0">
                  <c:v>28.579691733555304</c:v>
                </c:pt>
                <c:pt idx="1">
                  <c:v>52.749888306969893</c:v>
                </c:pt>
                <c:pt idx="2">
                  <c:v>68.10718130396927</c:v>
                </c:pt>
                <c:pt idx="3">
                  <c:v>70.10926397984305</c:v>
                </c:pt>
                <c:pt idx="4">
                  <c:v>49.404525769179997</c:v>
                </c:pt>
              </c:numCache>
            </c:numRef>
          </c:val>
          <c:smooth val="0"/>
        </c:ser>
        <c:ser>
          <c:idx val="1"/>
          <c:order val="1"/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9:$Q$83</c:f>
                <c:numCache>
                  <c:formatCode>General</c:formatCode>
                  <c:ptCount val="5"/>
                  <c:pt idx="0">
                    <c:v>2.0388252471511983</c:v>
                  </c:pt>
                  <c:pt idx="1">
                    <c:v>3.1050809010725828</c:v>
                  </c:pt>
                  <c:pt idx="2">
                    <c:v>4.0073503602923068</c:v>
                  </c:pt>
                  <c:pt idx="3">
                    <c:v>4.0252872127605315</c:v>
                  </c:pt>
                  <c:pt idx="4">
                    <c:v>3.4490972200598407</c:v>
                  </c:pt>
                </c:numCache>
              </c:numRef>
            </c:plus>
            <c:minus>
              <c:numRef>
                <c:f>dia!$P$79:$P$83</c:f>
                <c:numCache>
                  <c:formatCode>General</c:formatCode>
                  <c:ptCount val="5"/>
                  <c:pt idx="0">
                    <c:v>1.94708314764096</c:v>
                  </c:pt>
                  <c:pt idx="1">
                    <c:v>2.9769046428442323</c:v>
                  </c:pt>
                  <c:pt idx="2">
                    <c:v>3.8504611691329558</c:v>
                  </c:pt>
                  <c:pt idx="3">
                    <c:v>3.8677684182837027</c:v>
                  </c:pt>
                  <c:pt idx="4">
                    <c:v>3.30982895481605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9:$M$83</c:f>
              <c:numCache>
                <c:formatCode>General</c:formatCode>
                <c:ptCount val="5"/>
                <c:pt idx="0">
                  <c:v>30.596477649057743</c:v>
                </c:pt>
                <c:pt idx="1">
                  <c:v>54.451939740855224</c:v>
                </c:pt>
                <c:pt idx="2">
                  <c:v>76.148734566008386</c:v>
                </c:pt>
                <c:pt idx="3">
                  <c:v>76.552012436391763</c:v>
                </c:pt>
                <c:pt idx="4">
                  <c:v>62.60222005247034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500800"/>
        <c:axId val="81502976"/>
      </c:lineChart>
      <c:catAx>
        <c:axId val="815008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Time</a:t>
                </a:r>
                <a:r>
                  <a:rPr lang="en-US" sz="1200"/>
                  <a:t> </a:t>
                </a:r>
                <a:r>
                  <a:rPr lang="en-US" sz="1200" b="1" i="0" baseline="0">
                    <a:effectLst/>
                  </a:rPr>
                  <a:t>(min)</a:t>
                </a:r>
                <a:endParaRPr lang="en-US" sz="120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502976"/>
        <c:crosses val="autoZero"/>
        <c:auto val="1"/>
        <c:lblAlgn val="ctr"/>
        <c:lblOffset val="100"/>
        <c:noMultiLvlLbl val="0"/>
      </c:catAx>
      <c:valAx>
        <c:axId val="815029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Amylin</a:t>
                </a:r>
                <a:r>
                  <a:rPr lang="en-US" sz="1200"/>
                  <a:t> </a:t>
                </a:r>
                <a:r>
                  <a:rPr lang="en-US" sz="1200" b="1"/>
                  <a:t>(pg/m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1500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4:$Q$78</c:f>
                <c:numCache>
                  <c:formatCode>General</c:formatCode>
                  <c:ptCount val="5"/>
                  <c:pt idx="0">
                    <c:v>1.903662997231768</c:v>
                  </c:pt>
                  <c:pt idx="1">
                    <c:v>4.5244043092609161</c:v>
                  </c:pt>
                  <c:pt idx="2">
                    <c:v>3.7429121062351065</c:v>
                  </c:pt>
                  <c:pt idx="3">
                    <c:v>3.0462611486247688</c:v>
                  </c:pt>
                  <c:pt idx="4">
                    <c:v>3.0908943536700377</c:v>
                  </c:pt>
                </c:numCache>
              </c:numRef>
            </c:plus>
            <c:minus>
              <c:numRef>
                <c:f>dia!$P$74:$P$78</c:f>
                <c:numCache>
                  <c:formatCode>General</c:formatCode>
                  <c:ptCount val="5"/>
                  <c:pt idx="0">
                    <c:v>1.6834104273325874</c:v>
                  </c:pt>
                  <c:pt idx="1">
                    <c:v>4.0311439923697776</c:v>
                  </c:pt>
                  <c:pt idx="2">
                    <c:v>3.3296392108028563</c:v>
                  </c:pt>
                  <c:pt idx="3">
                    <c:v>2.7050924286844058</c:v>
                  </c:pt>
                  <c:pt idx="4">
                    <c:v>2.72408010319703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4:$M$78</c:f>
              <c:numCache>
                <c:formatCode>General</c:formatCode>
                <c:ptCount val="5"/>
                <c:pt idx="0">
                  <c:v>12.551053070782457</c:v>
                </c:pt>
                <c:pt idx="1">
                  <c:v>33.453470027042819</c:v>
                </c:pt>
                <c:pt idx="2">
                  <c:v>27.096968943175114</c:v>
                </c:pt>
                <c:pt idx="3">
                  <c:v>21.50241874558327</c:v>
                </c:pt>
                <c:pt idx="4">
                  <c:v>20.384625679854867</c:v>
                </c:pt>
              </c:numCache>
            </c:numRef>
          </c:val>
          <c:smooth val="0"/>
        </c:ser>
        <c:ser>
          <c:idx val="1"/>
          <c:order val="1"/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9:$Q$83</c:f>
                <c:numCache>
                  <c:formatCode>General</c:formatCode>
                  <c:ptCount val="5"/>
                  <c:pt idx="0">
                    <c:v>2.0074731008144688</c:v>
                  </c:pt>
                  <c:pt idx="1">
                    <c:v>5.0171664557214157</c:v>
                  </c:pt>
                  <c:pt idx="2">
                    <c:v>4.5504676078637232</c:v>
                  </c:pt>
                  <c:pt idx="3">
                    <c:v>3.9356650669147477</c:v>
                  </c:pt>
                  <c:pt idx="4">
                    <c:v>3.9758272414784379</c:v>
                  </c:pt>
                </c:numCache>
              </c:numRef>
            </c:plus>
            <c:minus>
              <c:numRef>
                <c:f>dia!$P$79:$P$83</c:f>
                <c:numCache>
                  <c:formatCode>General</c:formatCode>
                  <c:ptCount val="5"/>
                  <c:pt idx="0">
                    <c:v>1.7760576536803452</c:v>
                  </c:pt>
                  <c:pt idx="1">
                    <c:v>4.4743011217110862</c:v>
                  </c:pt>
                  <c:pt idx="2">
                    <c:v>4.0545627351242395</c:v>
                  </c:pt>
                  <c:pt idx="3">
                    <c:v>3.5026140530067096</c:v>
                  </c:pt>
                  <c:pt idx="4">
                    <c:v>3.53866380681762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9:$M$83</c:f>
              <c:numCache>
                <c:formatCode>General</c:formatCode>
                <c:ptCount val="5"/>
                <c:pt idx="0">
                  <c:v>13.349850973761145</c:v>
                </c:pt>
                <c:pt idx="1">
                  <c:v>37.532294779871798</c:v>
                </c:pt>
                <c:pt idx="2">
                  <c:v>33.667451300042266</c:v>
                </c:pt>
                <c:pt idx="3">
                  <c:v>28.659886122873029</c:v>
                </c:pt>
                <c:pt idx="4">
                  <c:v>28.98629223344427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6529920"/>
        <c:axId val="86536192"/>
      </c:lineChart>
      <c:catAx>
        <c:axId val="865299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Time</a:t>
                </a:r>
                <a:r>
                  <a:rPr lang="en-US" sz="1200"/>
                  <a:t> </a:t>
                </a:r>
                <a:r>
                  <a:rPr lang="en-US" sz="1200" b="1" i="0" baseline="0">
                    <a:effectLst/>
                  </a:rPr>
                  <a:t>(min)</a:t>
                </a:r>
                <a:endParaRPr lang="en-US" sz="120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536192"/>
        <c:crosses val="autoZero"/>
        <c:auto val="1"/>
        <c:lblAlgn val="ctr"/>
        <c:lblOffset val="100"/>
        <c:noMultiLvlLbl val="0"/>
      </c:catAx>
      <c:valAx>
        <c:axId val="865361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GLP-1 (pg/m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529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4:$Q$78</c:f>
                <c:numCache>
                  <c:formatCode>General</c:formatCode>
                  <c:ptCount val="5"/>
                  <c:pt idx="0">
                    <c:v>10.277813697657074</c:v>
                  </c:pt>
                  <c:pt idx="1">
                    <c:v>26.413505335186102</c:v>
                  </c:pt>
                  <c:pt idx="2">
                    <c:v>30.623748651120138</c:v>
                  </c:pt>
                  <c:pt idx="3">
                    <c:v>22.977051770498747</c:v>
                  </c:pt>
                  <c:pt idx="4">
                    <c:v>17.586829817981879</c:v>
                  </c:pt>
                </c:numCache>
              </c:numRef>
            </c:plus>
            <c:minus>
              <c:numRef>
                <c:f>dia!$P$74:$P$78</c:f>
                <c:numCache>
                  <c:formatCode>General</c:formatCode>
                  <c:ptCount val="5"/>
                  <c:pt idx="0">
                    <c:v>9.1797656395792444</c:v>
                  </c:pt>
                  <c:pt idx="1">
                    <c:v>24.554366194583338</c:v>
                  </c:pt>
                  <c:pt idx="2">
                    <c:v>28.605477595492147</c:v>
                  </c:pt>
                  <c:pt idx="3">
                    <c:v>21.256520118648552</c:v>
                  </c:pt>
                  <c:pt idx="4">
                    <c:v>16.1042139315335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4:$M$78</c:f>
              <c:numCache>
                <c:formatCode>General</c:formatCode>
                <c:ptCount val="5"/>
                <c:pt idx="0">
                  <c:v>44.937329337195607</c:v>
                </c:pt>
                <c:pt idx="1">
                  <c:v>225.87093981787439</c:v>
                </c:pt>
                <c:pt idx="2">
                  <c:v>284.48609674246609</c:v>
                </c:pt>
                <c:pt idx="3">
                  <c:v>181.15746994232364</c:v>
                </c:pt>
                <c:pt idx="4">
                  <c:v>117.2688642343779</c:v>
                </c:pt>
              </c:numCache>
            </c:numRef>
          </c:val>
          <c:smooth val="0"/>
        </c:ser>
        <c:ser>
          <c:idx val="1"/>
          <c:order val="1"/>
          <c:spPr>
            <a:ln w="12700" cap="rnd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dia!$Q$79:$Q$83</c:f>
                <c:numCache>
                  <c:formatCode>General</c:formatCode>
                  <c:ptCount val="5"/>
                  <c:pt idx="0">
                    <c:v>10.236405177342789</c:v>
                  </c:pt>
                  <c:pt idx="1">
                    <c:v>27.638469550031601</c:v>
                  </c:pt>
                  <c:pt idx="2">
                    <c:v>26.953283768850383</c:v>
                  </c:pt>
                  <c:pt idx="3">
                    <c:v>21.314183031413478</c:v>
                  </c:pt>
                  <c:pt idx="4">
                    <c:v>18.997040316837683</c:v>
                  </c:pt>
                </c:numCache>
              </c:numRef>
            </c:plus>
            <c:minus>
              <c:numRef>
                <c:f>dia!$P$79:$P$83</c:f>
                <c:numCache>
                  <c:formatCode>General</c:formatCode>
                  <c:ptCount val="5"/>
                  <c:pt idx="0">
                    <c:v>9.1408250021271868</c:v>
                  </c:pt>
                  <c:pt idx="1">
                    <c:v>25.731918026285825</c:v>
                  </c:pt>
                  <c:pt idx="2">
                    <c:v>25.073132569417083</c:v>
                  </c:pt>
                  <c:pt idx="3">
                    <c:v>19.663971383391356</c:v>
                  </c:pt>
                  <c:pt idx="4">
                    <c:v>17.4492015079246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dia!$R$68:$R$72</c:f>
              <c:numCache>
                <c:formatCode>General</c:formatCode>
                <c:ptCount val="5"/>
                <c:pt idx="0">
                  <c:v>0</c:v>
                </c:pt>
                <c:pt idx="1">
                  <c:v>30</c:v>
                </c:pt>
                <c:pt idx="2">
                  <c:v>60</c:v>
                </c:pt>
                <c:pt idx="3">
                  <c:v>120</c:v>
                </c:pt>
                <c:pt idx="4">
                  <c:v>180</c:v>
                </c:pt>
              </c:numCache>
            </c:numRef>
          </c:cat>
          <c:val>
            <c:numRef>
              <c:f>dia!$M$79:$M$83</c:f>
              <c:numCache>
                <c:formatCode>General</c:formatCode>
                <c:ptCount val="5"/>
                <c:pt idx="0">
                  <c:v>44.581341925905583</c:v>
                </c:pt>
                <c:pt idx="1">
                  <c:v>242.50320117798751</c:v>
                </c:pt>
                <c:pt idx="2">
                  <c:v>233.15623577389471</c:v>
                </c:pt>
                <c:pt idx="3">
                  <c:v>160.58803008289377</c:v>
                </c:pt>
                <c:pt idx="4">
                  <c:v>133.1856097767248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6561920"/>
        <c:axId val="86563840"/>
      </c:lineChart>
      <c:catAx>
        <c:axId val="865619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Time (min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563840"/>
        <c:crosses val="autoZero"/>
        <c:auto val="1"/>
        <c:lblAlgn val="ctr"/>
        <c:lblOffset val="100"/>
        <c:noMultiLvlLbl val="0"/>
      </c:catAx>
      <c:valAx>
        <c:axId val="865638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/>
                  <a:t>GIP (pg/mL)</a:t>
                </a:r>
              </a:p>
            </c:rich>
          </c:tx>
          <c:layout>
            <c:manualLayout>
              <c:xMode val="edge"/>
              <c:yMode val="edge"/>
              <c:x val="6.6947077105549271E-2"/>
              <c:y val="0.200501428339916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in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6561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3358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75626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39599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68046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1586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3937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7941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7200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895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614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5680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6FC93-FDD0-403F-8843-6356E6050B4D}" type="datetimeFigureOut">
              <a:rPr lang="it-IT" smtClean="0"/>
              <a:t>04/02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5521E-7460-4170-A51F-12B49DAD7A9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25442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7" name="Rectangle 187"/>
          <p:cNvSpPr>
            <a:spLocks noChangeArrowheads="1"/>
          </p:cNvSpPr>
          <p:nvPr/>
        </p:nvSpPr>
        <p:spPr bwMode="auto">
          <a:xfrm>
            <a:off x="4508082" y="-29752"/>
            <a:ext cx="1104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altLang="it-IT" sz="10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Helvetica" panose="020B0604020202020204" pitchFamily="34" charset="0"/>
              </a:rPr>
              <a:t> </a:t>
            </a:r>
            <a:endParaRPr kumimoji="0" lang="it-IT" altLang="it-IT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5855368" y="1331493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803744" y="10389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92" name="TextBox 191"/>
          <p:cNvSpPr txBox="1"/>
          <p:nvPr/>
        </p:nvSpPr>
        <p:spPr>
          <a:xfrm>
            <a:off x="3565750" y="49421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127872" y="103853"/>
            <a:ext cx="16374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Plasma glucose</a:t>
            </a:r>
            <a:endParaRPr lang="en-US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3874327" y="65836"/>
            <a:ext cx="24370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/>
              <a:t>Immunoreactive</a:t>
            </a:r>
            <a:r>
              <a:rPr lang="en-US" b="1" dirty="0" smtClean="0"/>
              <a:t> insulin</a:t>
            </a:r>
            <a:endParaRPr lang="en-US" b="1" dirty="0"/>
          </a:p>
        </p:txBody>
      </p:sp>
      <p:graphicFrame>
        <p:nvGraphicFramePr>
          <p:cNvPr id="41" name="Graf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7705939"/>
              </p:ext>
            </p:extLst>
          </p:nvPr>
        </p:nvGraphicFramePr>
        <p:xfrm>
          <a:off x="497302" y="487083"/>
          <a:ext cx="2340496" cy="21295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6" name="Graf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64935"/>
              </p:ext>
            </p:extLst>
          </p:nvPr>
        </p:nvGraphicFramePr>
        <p:xfrm>
          <a:off x="3285430" y="434234"/>
          <a:ext cx="2249078" cy="21656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2" name="TextBox 51"/>
          <p:cNvSpPr txBox="1"/>
          <p:nvPr/>
        </p:nvSpPr>
        <p:spPr>
          <a:xfrm>
            <a:off x="858192" y="265461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214850" y="2654234"/>
            <a:ext cx="1113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-peptide</a:t>
            </a:r>
            <a:endParaRPr lang="en-US" b="1" dirty="0"/>
          </a:p>
        </p:txBody>
      </p:sp>
      <p:graphicFrame>
        <p:nvGraphicFramePr>
          <p:cNvPr id="54" name="Graf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2550087"/>
              </p:ext>
            </p:extLst>
          </p:nvPr>
        </p:nvGraphicFramePr>
        <p:xfrm>
          <a:off x="497302" y="2918922"/>
          <a:ext cx="2381161" cy="21656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3699370" y="2654234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023498" y="2654194"/>
            <a:ext cx="852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mylin</a:t>
            </a:r>
            <a:endParaRPr lang="en-US" b="1" dirty="0"/>
          </a:p>
        </p:txBody>
      </p:sp>
      <p:graphicFrame>
        <p:nvGraphicFramePr>
          <p:cNvPr id="30" name="Graf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7242385"/>
              </p:ext>
            </p:extLst>
          </p:nvPr>
        </p:nvGraphicFramePr>
        <p:xfrm>
          <a:off x="3331352" y="3023566"/>
          <a:ext cx="2353459" cy="21005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8" name="TextBox 37"/>
          <p:cNvSpPr txBox="1"/>
          <p:nvPr/>
        </p:nvSpPr>
        <p:spPr>
          <a:xfrm>
            <a:off x="1028332" y="510899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E</a:t>
            </a:r>
            <a:endParaRPr lang="en-US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3723005" y="510895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352460" y="5108957"/>
            <a:ext cx="740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GLP-1</a:t>
            </a:r>
            <a:endParaRPr lang="en-US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4186911" y="5149731"/>
            <a:ext cx="5164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GIP</a:t>
            </a:r>
            <a:endParaRPr lang="en-US" b="1" dirty="0"/>
          </a:p>
        </p:txBody>
      </p:sp>
      <p:graphicFrame>
        <p:nvGraphicFramePr>
          <p:cNvPr id="61" name="Graf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22564513"/>
              </p:ext>
            </p:extLst>
          </p:nvPr>
        </p:nvGraphicFramePr>
        <p:xfrm>
          <a:off x="595764" y="5450873"/>
          <a:ext cx="2169543" cy="23455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2" name="Graf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4047208"/>
              </p:ext>
            </p:extLst>
          </p:nvPr>
        </p:nvGraphicFramePr>
        <p:xfrm>
          <a:off x="3425085" y="5487359"/>
          <a:ext cx="2430283" cy="23251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63" name="TextBox 62"/>
          <p:cNvSpPr txBox="1"/>
          <p:nvPr/>
        </p:nvSpPr>
        <p:spPr>
          <a:xfrm>
            <a:off x="0" y="7789942"/>
            <a:ext cx="685800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/>
              <a:t>Supplemental </a:t>
            </a:r>
            <a:r>
              <a:rPr lang="en-US" sz="1200" b="1" dirty="0" smtClean="0"/>
              <a:t>Figure 2. Postprandial changes in plasma concentrations of glucose, </a:t>
            </a:r>
            <a:r>
              <a:rPr lang="en-US" sz="1200" b="1" dirty="0" err="1" smtClean="0"/>
              <a:t>immunoreactive</a:t>
            </a:r>
            <a:r>
              <a:rPr lang="en-US" sz="1200" b="1" dirty="0" smtClean="0"/>
              <a:t> insulin, C-peptide amylin, GLP-1 and GIP in patients with diabetes (T2D), after the ingestions of the V-meal (white symbols) and the M-meal. (black symbols). </a:t>
            </a:r>
            <a:r>
              <a:rPr lang="en-US" sz="1200" dirty="0" smtClean="0"/>
              <a:t>Data are expressed as mean with 95% confidence intervals, using a repeated-measures ANOVA. </a:t>
            </a:r>
          </a:p>
          <a:p>
            <a:r>
              <a:rPr lang="en-US" sz="1200" b="1" dirty="0" smtClean="0"/>
              <a:t>A: Plasma glucose: </a:t>
            </a:r>
            <a:r>
              <a:rPr lang="en-US" sz="1200" dirty="0" smtClean="0"/>
              <a:t>Factors diet: F=1, p=0.309; time: F=118.1, p&lt;0.001; interaction diet x time: F=0.3, p=0.889. </a:t>
            </a:r>
            <a:r>
              <a:rPr lang="en-US" sz="1200" b="1" dirty="0" smtClean="0"/>
              <a:t>B : </a:t>
            </a:r>
            <a:r>
              <a:rPr lang="en-US" sz="1200" b="1" dirty="0" err="1" smtClean="0"/>
              <a:t>Immunoreactive</a:t>
            </a:r>
            <a:r>
              <a:rPr lang="en-US" sz="1200" b="1" dirty="0" smtClean="0"/>
              <a:t> insulin : </a:t>
            </a:r>
            <a:r>
              <a:rPr lang="en-US" sz="1200" dirty="0"/>
              <a:t>Factors diet: </a:t>
            </a:r>
            <a:r>
              <a:rPr lang="en-US" sz="1200" dirty="0" smtClean="0"/>
              <a:t>F=8.1</a:t>
            </a:r>
            <a:r>
              <a:rPr lang="en-US" sz="1200" dirty="0"/>
              <a:t>, </a:t>
            </a:r>
            <a:r>
              <a:rPr lang="en-US" sz="1200" dirty="0" smtClean="0"/>
              <a:t>p=0.005; </a:t>
            </a:r>
            <a:r>
              <a:rPr lang="en-US" sz="1200" dirty="0"/>
              <a:t>time: </a:t>
            </a:r>
            <a:r>
              <a:rPr lang="en-US" sz="1200" dirty="0" smtClean="0"/>
              <a:t>F=185.2, </a:t>
            </a:r>
            <a:r>
              <a:rPr lang="en-US" sz="1200" dirty="0"/>
              <a:t>p&lt;0.001; interaction diet x time: </a:t>
            </a:r>
            <a:r>
              <a:rPr lang="en-US" sz="1200" dirty="0" smtClean="0"/>
              <a:t>F=3.6, p=0.008. </a:t>
            </a:r>
            <a:r>
              <a:rPr lang="en-US" sz="1200" b="1" dirty="0" smtClean="0"/>
              <a:t>C </a:t>
            </a:r>
            <a:r>
              <a:rPr lang="en-US" sz="1200" b="1" dirty="0"/>
              <a:t>: </a:t>
            </a:r>
            <a:r>
              <a:rPr lang="en-US" sz="1200" b="1" dirty="0" smtClean="0"/>
              <a:t>C-peptide: </a:t>
            </a:r>
            <a:r>
              <a:rPr lang="en-US" sz="1200" dirty="0"/>
              <a:t>Factors diet: </a:t>
            </a:r>
            <a:r>
              <a:rPr lang="en-US" sz="1200" dirty="0" smtClean="0"/>
              <a:t>F=13.4, </a:t>
            </a:r>
            <a:r>
              <a:rPr lang="en-US" sz="1200" dirty="0"/>
              <a:t>p&lt;0.001</a:t>
            </a:r>
            <a:r>
              <a:rPr lang="en-US" sz="1200" dirty="0" smtClean="0"/>
              <a:t>; </a:t>
            </a:r>
            <a:r>
              <a:rPr lang="en-US" sz="1200" dirty="0"/>
              <a:t>time: </a:t>
            </a:r>
            <a:r>
              <a:rPr lang="en-US" sz="1200" dirty="0" smtClean="0"/>
              <a:t>F=222.4, </a:t>
            </a:r>
            <a:r>
              <a:rPr lang="en-US" sz="1200" dirty="0"/>
              <a:t>p&lt;0.001; interaction diet x time: </a:t>
            </a:r>
            <a:r>
              <a:rPr lang="en-US" sz="1200" dirty="0" smtClean="0"/>
              <a:t>F=2.8, p=0.026. </a:t>
            </a:r>
            <a:r>
              <a:rPr lang="en-US" sz="1200" b="1" dirty="0" smtClean="0"/>
              <a:t>D </a:t>
            </a:r>
            <a:r>
              <a:rPr lang="en-US" sz="1200" b="1" dirty="0"/>
              <a:t>: </a:t>
            </a:r>
            <a:r>
              <a:rPr lang="en-US" sz="1200" b="1" dirty="0" smtClean="0"/>
              <a:t>Amylin: </a:t>
            </a:r>
            <a:r>
              <a:rPr lang="en-US" sz="1200" dirty="0" smtClean="0"/>
              <a:t>Factors </a:t>
            </a:r>
            <a:r>
              <a:rPr lang="en-US" sz="1200" dirty="0"/>
              <a:t>diet: </a:t>
            </a:r>
            <a:r>
              <a:rPr lang="en-US" sz="1200" dirty="0" smtClean="0"/>
              <a:t>F=18.2, </a:t>
            </a:r>
            <a:r>
              <a:rPr lang="en-US" sz="1200" dirty="0"/>
              <a:t>p&lt;0.001; time: </a:t>
            </a:r>
            <a:r>
              <a:rPr lang="en-US" sz="1200" dirty="0" smtClean="0"/>
              <a:t>F=154.8, </a:t>
            </a:r>
            <a:r>
              <a:rPr lang="en-US" sz="1200" dirty="0"/>
              <a:t>p&lt;0.001; interaction diet x time: </a:t>
            </a:r>
            <a:r>
              <a:rPr lang="en-US" sz="1200" dirty="0" smtClean="0"/>
              <a:t>F=2, p=0.097. </a:t>
            </a:r>
            <a:r>
              <a:rPr lang="en-US" sz="1200" b="1" dirty="0" smtClean="0"/>
              <a:t>E: </a:t>
            </a:r>
            <a:r>
              <a:rPr lang="en-US" sz="1200" b="1" dirty="0"/>
              <a:t>GLP-1: </a:t>
            </a:r>
            <a:r>
              <a:rPr lang="en-US" sz="1200" dirty="0" smtClean="0"/>
              <a:t>Factors </a:t>
            </a:r>
            <a:r>
              <a:rPr lang="en-US" sz="1200" dirty="0"/>
              <a:t>diet: F=12, p&lt;0.001; time: F=31.8, p&lt;0.001; interaction diet x time: F=0.8, p=0.529. </a:t>
            </a:r>
            <a:r>
              <a:rPr lang="en-US" sz="1200" b="1" dirty="0" smtClean="0"/>
              <a:t>F: GIP</a:t>
            </a:r>
            <a:r>
              <a:rPr lang="en-US" sz="1200" b="1" dirty="0"/>
              <a:t>: </a:t>
            </a:r>
            <a:r>
              <a:rPr lang="en-US" sz="1200" dirty="0" smtClean="0"/>
              <a:t>Factors </a:t>
            </a:r>
            <a:r>
              <a:rPr lang="en-US" sz="1200" dirty="0"/>
              <a:t>diet: F=0.3, p=0.566; time: F=88.9, p&lt;0.001; interaction diet x time: F=1.3, p=0.281.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1067097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82</TotalTime>
  <Words>283</Words>
  <Application>Microsoft Office PowerPoint</Application>
  <PresentationFormat>A4 Paper (210x297 mm)</PresentationFormat>
  <Paragraphs>2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</dc:creator>
  <cp:lastModifiedBy>Hana Kahleova</cp:lastModifiedBy>
  <cp:revision>63</cp:revision>
  <cp:lastPrinted>2018-11-30T15:01:18Z</cp:lastPrinted>
  <dcterms:created xsi:type="dcterms:W3CDTF">2017-08-23T17:01:57Z</dcterms:created>
  <dcterms:modified xsi:type="dcterms:W3CDTF">2019-02-04T13:38:39Z</dcterms:modified>
</cp:coreProperties>
</file>